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media/image2.svg" ContentType="image/svg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  <p:sldId id="264" r:id="rId4"/>
    <p:sldId id="263" r:id="rId5"/>
    <p:sldId id="261" r:id="rId6"/>
    <p:sldId id="262" r:id="rId7"/>
    <p:sldId id="265" r:id="rId8"/>
    <p:sldId id="266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27E263-F6BF-4D16-A184-D91C6342FDC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252C928-E885-4765-8F93-6E8C6D30460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svg"/><Relationship Id="rId1" Type="http://schemas.openxmlformats.org/officeDocument/2006/relationships/image" Target="../media/image1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463040" y="1026160"/>
          <a:ext cx="9000000" cy="3960000"/>
        </p:xfrm>
        <a:graphic>
          <a:graphicData uri="http://schemas.openxmlformats.org/drawingml/2006/table">
            <a:tbl>
              <a:tblPr/>
              <a:tblGrid>
                <a:gridCol w="1984888"/>
                <a:gridCol w="3507556"/>
                <a:gridCol w="3507556"/>
              </a:tblGrid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ene nam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orward primer （5′-3′）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verse primer （5′-3′）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12G0511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TGCATGTGAAGAGGAGAATTG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AAGGGACAAGCGGATTGAATA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05G00005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TGTTACTAATGGTGTGAAGGTT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AAAGCTCGCCCTGTCATAT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05G2199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CGTTGCTCACTTCCACTCT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TGTCTCCTTCGCCGTTT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14G2136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ACTTTGTTCATGGTTGGGTT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AGCGAGGTGAGTAGCG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19G1356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TTACCTCAATGGCTTCAAGAAA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ATAGTTCAGGACAACCGACAATT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05G1755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TAGGTGATGGGCAGGACG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AAGACACCCCTACTTGCTG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14G2237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CACTGGTCCTGGCAATTATC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TCTTGGCTTCCTCCTCTTGATT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17G172400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AGAATGGATTCAGGTGAAGAAA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GATGGAGTTGGCACGGATTG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lyma.19G07270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GACCTTGCTGCCCTTT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CCTCAACAACAGTTTCTCGTAAAG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1463040" y="656828"/>
            <a:ext cx="6096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 S1.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for quantitative real-time PCR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413658" y="446314"/>
          <a:ext cx="10476600" cy="4319159"/>
        </p:xfrm>
        <a:graphic>
          <a:graphicData uri="http://schemas.openxmlformats.org/drawingml/2006/table">
            <a:tbl>
              <a:tblPr/>
              <a:tblGrid>
                <a:gridCol w="622224"/>
                <a:gridCol w="813511"/>
                <a:gridCol w="981244"/>
                <a:gridCol w="1241232"/>
                <a:gridCol w="578682"/>
                <a:gridCol w="578682"/>
                <a:gridCol w="1065111"/>
                <a:gridCol w="1660568"/>
                <a:gridCol w="2935346"/>
              </a:tblGrid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ample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w bases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lean bases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Valid bases(%)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Q30(%)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(%)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otal </a:t>
                      </a:r>
                      <a:r>
                        <a:rPr lang="en-US" sz="12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adsa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otal mapped </a:t>
                      </a:r>
                      <a:r>
                        <a:rPr lang="en-US" sz="12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eadsb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tio (total mapped /total)c （%）</a:t>
                      </a:r>
                      <a:endParaRPr lang="en-US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C1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760870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311496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27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27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31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810142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26979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61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C2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282700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160254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31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16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39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137806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2486190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03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C3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559592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946904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14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15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12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09340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595511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79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S1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93356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404226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11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93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94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084420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705295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9.05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S2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180634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359286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3.47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88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09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068694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66656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97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S3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760444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026930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3.61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81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77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20509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384287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7.67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1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8003146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355812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49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23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29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987142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015761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7.74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2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297056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628454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3.69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84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22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235622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553861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26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C3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57813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995354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3.93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99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72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715862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089690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42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S1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840294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322744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12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14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98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243960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62641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43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S2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20269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784766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3.83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01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42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53026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007939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57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2243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S3</a:t>
                      </a:r>
                      <a:endParaRPr lang="en-US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880540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434290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30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12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33%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188412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524208</a:t>
                      </a:r>
                      <a:endParaRPr lang="en-US" altLang="zh-CN" sz="1200" b="0" i="0" u="none" strike="noStrike" kern="12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31%</a:t>
                      </a:r>
                      <a:endParaRPr lang="en-US" altLang="zh-CN" sz="12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" name="文本框 3"/>
          <p:cNvSpPr txBox="1"/>
          <p:nvPr/>
        </p:nvSpPr>
        <p:spPr>
          <a:xfrm>
            <a:off x="500744" y="4931343"/>
            <a:ext cx="8142514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aw bases: The number of original sequencing bases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lean bases: The amount of sequencing bases after filtering 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alid bases(%): The ratio of bases between the clean and the raw bases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Q30(%): The percentage of raw bases with a Phred value &gt; 30 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C(%): The total number of G and C in clean bases as a percentage of the total number of bases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 Total reads: The number of sequencing sequences filtered by sequencing data (Clean reads)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otal mapped reads: The number of sequencing sequences that can be located on the genome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atio (total mapped /total)(%): The ratio of reads between the total mapped and the total reads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13657" y="110775"/>
            <a:ext cx="701978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 S2. Quality Metrics of 36-hour Transcriptome Sequencing Data</a:t>
            </a:r>
            <a:endParaRPr lang="en-US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/>
        </p:nvGraphicFramePr>
        <p:xfrm>
          <a:off x="250372" y="555172"/>
          <a:ext cx="11092544" cy="4057911"/>
        </p:xfrm>
        <a:graphic>
          <a:graphicData uri="http://schemas.openxmlformats.org/drawingml/2006/table">
            <a:tbl>
              <a:tblPr/>
              <a:tblGrid>
                <a:gridCol w="630466"/>
                <a:gridCol w="886307"/>
                <a:gridCol w="1069051"/>
                <a:gridCol w="1352303"/>
                <a:gridCol w="630466"/>
                <a:gridCol w="630466"/>
                <a:gridCol w="1069051"/>
                <a:gridCol w="1717791"/>
                <a:gridCol w="3106643"/>
              </a:tblGrid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ampl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w bas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lean base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Valid bases(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Q30(%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GC(%)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otal read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otal mapped read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tio (total mapped /total) （%）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C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885118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345738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08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97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05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71169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263696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87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C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47812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03281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24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18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81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02029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62213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98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C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26854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76200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3.45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84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43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905504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44967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69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S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16545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99963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33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94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48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051106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64883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85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S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46785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97234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26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25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78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135068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703523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92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DS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24407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95133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00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93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74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66035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532943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9.07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612667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99851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11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04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28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42528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2851841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28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364796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1426392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91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42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87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73388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147157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56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84733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20304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3.83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82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17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9490052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695767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7.99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S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276356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122408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3.82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98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81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66114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033910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38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S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0609704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820336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07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6.11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4.67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55631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01883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57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S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012466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482538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4.09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5.89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5.22%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353409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2962590</a:t>
                      </a:r>
                      <a:endParaRPr lang="en-US" altLang="zh-CN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8.30%</a:t>
                      </a:r>
                      <a:endParaRPr lang="en-US" alt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" name="文本框 3"/>
          <p:cNvSpPr txBox="1"/>
          <p:nvPr/>
        </p:nvSpPr>
        <p:spPr>
          <a:xfrm>
            <a:off x="250372" y="4931343"/>
            <a:ext cx="8719457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aw bases: The number of original sequencing bases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lean bases: The amount of sequencing bases after filtering 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alid bases(%): The ratio of bases between the clean and the raw bases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Q30(%): The percentage of raw bases with a Phred value &gt; 30 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GC(%): The total number of G and C in clean bases as a percentage of the total number of bases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 Total reads: The number of sequencing sequences filtered by sequencing data (Clean reads)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otal mapped reads: The number of sequencing sequences that can be located on the genome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atio (total mapped /total)(%): The ratio of reads between the total mapped and the total reads.</a:t>
            </a:r>
            <a:endParaRPr kumimoji="0" lang="en-US" altLang="zh-CN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63286" y="211376"/>
            <a:ext cx="67341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able S3. Quality Metrics of 48-hour Transcriptome Sequencing Data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975954" y="3427762"/>
          <a:ext cx="8697600" cy="1497600"/>
        </p:xfrm>
        <a:graphic>
          <a:graphicData uri="http://schemas.openxmlformats.org/drawingml/2006/table">
            <a:tbl>
              <a:tblPr/>
              <a:tblGrid>
                <a:gridCol w="1896835"/>
                <a:gridCol w="2236177"/>
                <a:gridCol w="2220516"/>
                <a:gridCol w="2344072"/>
              </a:tblGrid>
              <a:tr h="409524"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kumimoji="0" lang="en-US" altLang="zh-CN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82 Control</a:t>
                      </a:r>
                      <a:r>
                        <a:rPr lang="zh-CN" alt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）</a:t>
                      </a:r>
                      <a:endParaRPr 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kumimoji="0" lang="en-US" altLang="zh-CN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82 Salt Treatment</a:t>
                      </a:r>
                      <a:r>
                        <a:rPr lang="zh-CN" alt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）</a:t>
                      </a:r>
                      <a:endParaRPr 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kumimoji="0" lang="en-US" altLang="zh-CN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063 Control </a:t>
                      </a:r>
                      <a:r>
                        <a:rPr lang="zh-CN" alt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）</a:t>
                      </a:r>
                      <a:endParaRPr 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kumimoji="0" lang="en-US" altLang="zh-CN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063 Salt </a:t>
                      </a:r>
                      <a:r>
                        <a:rPr kumimoji="0" lang="en-US" altLang="zh-CN" sz="1400" b="0" i="0" u="none" strike="noStrike" kern="1200" cap="none" spc="0" normalizeH="0" baseline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eatmentv</a:t>
                      </a:r>
                      <a:r>
                        <a:rPr lang="zh-CN" alt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lang="en-US" altLang="zh-CN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zh-CN" alt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）</a:t>
                      </a:r>
                      <a:endParaRPr lang="zh-CN" alt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62692"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C1</a:t>
                      </a:r>
                      <a:endParaRPr 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S1</a:t>
                      </a:r>
                      <a:endParaRPr 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C1</a:t>
                      </a:r>
                      <a:endParaRPr lang="en-US" sz="1400" kern="120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S1</a:t>
                      </a:r>
                      <a:endParaRPr lang="en-US" sz="1400" kern="120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62692"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C2</a:t>
                      </a:r>
                      <a:endParaRPr lang="en-US" sz="1400" kern="120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S2</a:t>
                      </a:r>
                      <a:endParaRPr lang="en-US" sz="1400" kern="120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C2</a:t>
                      </a:r>
                      <a:endParaRPr 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S2</a:t>
                      </a:r>
                      <a:endParaRPr 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62692"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C3</a:t>
                      </a:r>
                      <a:endParaRPr lang="en-US" sz="1400" kern="120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S3</a:t>
                      </a:r>
                      <a:endParaRPr lang="en-US" sz="1400" kern="120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C3</a:t>
                      </a:r>
                      <a:endParaRPr lang="en-US" sz="1400" kern="120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 defTabSz="914400" rtl="0" eaLnBrk="1" latinLnBrk="0" hangingPunct="1">
                        <a:lnSpc>
                          <a:spcPts val="2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defRPr/>
                      </a:pPr>
                      <a:r>
                        <a:rPr lang="en-US" sz="1400" kern="1200" dirty="0">
                          <a:solidFill>
                            <a:prstClr val="black"/>
                          </a:solidFill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S3</a:t>
                      </a:r>
                      <a:endParaRPr lang="en-US" sz="1400" kern="1200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975954" y="3049079"/>
            <a:ext cx="816804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 S5. Grouping of 48-hour transcriptome samples under different salt stress treatments and control tabl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085850" y="5106953"/>
            <a:ext cx="6097314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altLang="zh-CN" sz="18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82 Control: Untreated W82 sample</a:t>
            </a:r>
            <a:endParaRPr lang="en-US" altLang="zh-CN" sz="18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defRPr/>
            </a:pPr>
            <a:r>
              <a:rPr lang="en-US" altLang="zh-CN" sz="18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82 Salt Treatment: W82 exposed to salt stress</a:t>
            </a:r>
            <a:endParaRPr lang="en-US" altLang="zh-CN" sz="18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defRPr/>
            </a:pPr>
            <a:r>
              <a:rPr lang="en-US" altLang="zh-CN" sz="18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063 Control : Untreated R063 sample</a:t>
            </a:r>
            <a:endParaRPr lang="en-US" altLang="zh-CN" sz="18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defRPr/>
            </a:pPr>
            <a:r>
              <a:rPr lang="en-US" altLang="zh-CN" sz="18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063 Salt Treatment: R063 exposed to salt stress</a:t>
            </a:r>
            <a:endParaRPr lang="zh-CN" altLang="en-US" sz="18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5"/>
          <p:cNvGraphicFramePr>
            <a:graphicFrameLocks noGrp="1"/>
          </p:cNvGraphicFramePr>
          <p:nvPr/>
        </p:nvGraphicFramePr>
        <p:xfrm>
          <a:off x="1778000" y="2854960"/>
          <a:ext cx="8698188" cy="1496346"/>
        </p:xfrm>
        <a:graphic>
          <a:graphicData uri="http://schemas.openxmlformats.org/drawingml/2006/table">
            <a:tbl>
              <a:tblPr/>
              <a:tblGrid>
                <a:gridCol w="2174547"/>
                <a:gridCol w="2174547"/>
                <a:gridCol w="2174547"/>
                <a:gridCol w="2174547"/>
              </a:tblGrid>
              <a:tr h="406392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82 Control</a:t>
                      </a:r>
                      <a:r>
                        <a:rPr kumimoji="0" lang="zh-CN" alt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）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82 Salt Treatment</a:t>
                      </a:r>
                      <a:r>
                        <a:rPr kumimoji="0" lang="zh-CN" alt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）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063 Control </a:t>
                      </a:r>
                      <a:r>
                        <a:rPr kumimoji="0" lang="zh-CN" alt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）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063 Salt Treatment</a:t>
                      </a:r>
                      <a:r>
                        <a:rPr kumimoji="0" lang="zh-CN" alt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</a:t>
                      </a: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）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63318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C1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S1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1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S1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63318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C2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S2</a:t>
                      </a:r>
                      <a:endParaRPr kumimoji="0" lang="en-US" sz="1400" b="0" i="0" u="none" strike="noStrike" kern="1200" cap="none" spc="0" normalizeH="0" baseline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2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S2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63318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C3</a:t>
                      </a:r>
                      <a:endParaRPr kumimoji="0" lang="en-US" sz="1400" b="0" i="0" u="none" strike="noStrike" kern="1200" cap="none" spc="0" normalizeH="0" baseline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ES3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3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sz="1400" b="0" i="0" u="none" strike="noStrike" kern="1200" cap="none" spc="0" normalizeH="0" baseline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S3</a:t>
                      </a:r>
                      <a:endParaRPr kumimoji="0" lang="en-US" sz="1400" b="0" i="0" u="none" strike="noStrike" kern="1200" cap="none" spc="0" normalizeH="0" baseline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8" name="文本框 7"/>
          <p:cNvSpPr txBox="1"/>
          <p:nvPr/>
        </p:nvSpPr>
        <p:spPr>
          <a:xfrm>
            <a:off x="1777999" y="2547183"/>
            <a:ext cx="830072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 S4. Grouping of 36-hour transcriptome samples under different salt stress treatments and control tabl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889892" y="4659083"/>
            <a:ext cx="6097314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82 Control: Untreated W82 sample</a:t>
            </a:r>
            <a:endParaRPr lang="en-US" altLang="zh-CN" sz="14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defRPr/>
            </a:pP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W82 Salt Treatment: W82 exposed to salt stress</a:t>
            </a:r>
            <a:endParaRPr lang="en-US" altLang="zh-CN" sz="14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defRPr/>
            </a:pP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063 Control : Untreated R063 sample</a:t>
            </a:r>
            <a:endParaRPr lang="en-US" altLang="zh-CN" sz="14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defRPr/>
            </a:pPr>
            <a:r>
              <a:rPr lang="en-US" altLang="zh-CN" sz="1400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R063 Salt Treatment: R063 exposed to salt stress</a:t>
            </a:r>
            <a:endParaRPr lang="zh-CN" altLang="en-US" sz="1400" dirty="0">
              <a:solidFill>
                <a:prstClr val="black"/>
              </a:solidFill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图片3"/>
          <p:cNvPicPr>
            <a:picLocks noChangeAspect="1"/>
          </p:cNvPicPr>
          <p:nvPr/>
        </p:nvPicPr>
        <p:blipFill>
          <a:blip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tretch>
            <a:fillRect/>
          </a:stretch>
        </p:blipFill>
        <p:spPr>
          <a:xfrm>
            <a:off x="2251075" y="93980"/>
            <a:ext cx="7189470" cy="611187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142240" y="6294120"/>
            <a:ext cx="12049760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Figure 1 Candidate gene expression validation(A-C). FPKM heatmap of genes(D). The abscissa in the figure is the sample name, and the ordinate is the relative expression. (** means P ≤ 0.01 in T test, *** means P ≤ 0.005in T-test,  **** means P ≤ 0.0001 in T-test).</a:t>
            </a:r>
            <a:endParaRPr lang="zh-CN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-635" y="5699125"/>
            <a:ext cx="12192635" cy="64516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just">
              <a:buClrTx/>
              <a:buSzTx/>
              <a:buFontTx/>
            </a:pPr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2 Scale-free topology model fit and mean connectivity in the network analysis.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 The scale independence of the network was validated using the scale-free topology model. The R² values (signed) for different soft thresholds (power) are plotted. The optimal power value (β = 8) was selected based on the highest R² . </a:t>
            </a:r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 Mean connectivity across varying soft thresholds (power). As the threshold increased, the mean connectivity decreased, indicating stronger module separation. Error bars represent standard deviations.</a:t>
            </a:r>
            <a:endParaRPr lang="en-US" altLang="zh-CN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 descr="6.2 WGCNA图片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008505" y="-4445"/>
            <a:ext cx="7129780" cy="570357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171065" y="-4445"/>
            <a:ext cx="315595" cy="3384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089785" y="3072130"/>
            <a:ext cx="4781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02</Words>
  <Application>WPS 演示</Application>
  <PresentationFormat>宽屏</PresentationFormat>
  <Paragraphs>638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7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等线 Light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n pan</dc:creator>
  <cp:lastModifiedBy>   </cp:lastModifiedBy>
  <cp:revision>8</cp:revision>
  <dcterms:created xsi:type="dcterms:W3CDTF">2025-04-13T05:55:00Z</dcterms:created>
  <dcterms:modified xsi:type="dcterms:W3CDTF">2025-06-23T16:53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D40B4088A4040E6BAA832E9590DA9DD_13</vt:lpwstr>
  </property>
  <property fmtid="{D5CDD505-2E9C-101B-9397-08002B2CF9AE}" pid="3" name="KSOProductBuildVer">
    <vt:lpwstr>2052-12.1.0.21171</vt:lpwstr>
  </property>
</Properties>
</file>